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0" r:id="rId2"/>
    <p:sldId id="271" r:id="rId3"/>
    <p:sldId id="274" r:id="rId4"/>
  </p:sldIdLst>
  <p:sldSz cx="12192000" cy="6858000"/>
  <p:notesSz cx="6858000" cy="9144000"/>
  <p:custDataLst>
    <p:tags r:id="rId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284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70BF37-B15E-4B21-B022-266C8CFE9077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C2BDA-14B1-45CB-8A6D-18DFE6802B5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09545" y="291725"/>
            <a:ext cx="2594912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Fig. 1</a:t>
            </a:r>
            <a:r>
              <a:rPr lang="en-US" altLang="zh-CN" b="1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a</a:t>
            </a:r>
            <a:endParaRPr kumimoji="0" lang="en-US" altLang="zh-CN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94095" y="1275185"/>
            <a:ext cx="4707006" cy="3441192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812290" y="5206365"/>
            <a:ext cx="9238615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altLang="zh-CN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 S1 Relationships between serum DKK1 level and age, serum biochemical indicator levels, and fracture incidence in  OI</a:t>
            </a:r>
            <a:r>
              <a:rPr lang="en-US" altLang="en-GB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GB" altLang="zh-CN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hildren</a:t>
            </a:r>
          </a:p>
          <a:p>
            <a:pPr>
              <a:lnSpc>
                <a:spcPct val="150000"/>
              </a:lnSpc>
            </a:pPr>
            <a:r>
              <a:rPr lang="en-US" altLang="zh-CN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 </a:t>
            </a:r>
            <a:r>
              <a:rPr lang="en-GB" altLang="zh-CN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1a Correlations of serum DKK1 concentration with age</a:t>
            </a:r>
            <a:r>
              <a:rPr lang="en-US" altLang="en-GB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of OI</a:t>
            </a:r>
            <a:r>
              <a:rPr lang="en-GB" altLang="zh-CN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children</a:t>
            </a:r>
            <a:endParaRPr kumimoji="0" lang="en-US" altLang="zh-CN" sz="1200" b="1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endParaRPr kumimoji="0" lang="en-US" altLang="zh-CN" sz="1200" b="1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kumimoji="0" lang="en-US" altLang="zh-CN" sz="1200" b="1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409545" y="291725"/>
            <a:ext cx="25949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. 1b</a:t>
            </a:r>
            <a:endParaRPr kumimoji="0" lang="en-US" altLang="zh-CN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018246" y="5906759"/>
            <a:ext cx="9586418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buFontTx/>
              <a:buNone/>
              <a:defRPr/>
            </a:pPr>
            <a:endParaRPr kumimoji="0" lang="en-US" altLang="zh-CN" sz="1200" b="1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936496" y="645795"/>
            <a:ext cx="3660013" cy="261429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495403" y="645795"/>
            <a:ext cx="3710963" cy="262699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960834" y="3260090"/>
            <a:ext cx="3660013" cy="2595069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563434" y="3274695"/>
            <a:ext cx="3663801" cy="263207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811020" y="6041390"/>
            <a:ext cx="924941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 S1b Correlations between serum DKK1 concentration and serum biochemical indicators</a:t>
            </a:r>
            <a:r>
              <a:rPr lang="en-US" altLang="en-GB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of </a:t>
            </a:r>
            <a:r>
              <a:rPr lang="en-GB" altLang="zh-CN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, 25OHD, ALT, and Cr in OI</a:t>
            </a:r>
            <a:r>
              <a:rPr lang="en-US" altLang="en-GB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GB" altLang="zh-CN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hildren</a:t>
            </a:r>
          </a:p>
          <a:p>
            <a:endParaRPr lang="en-GB" altLang="zh-CN" sz="1200" b="1" kern="10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sz="1200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I: osteogenesis imperfecta, P: phosphorus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25OHD: 25-hydroxyvitamin D, </a:t>
            </a:r>
            <a:r>
              <a:rPr lang="en-US" altLang="zh-CN" sz="1200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LT: glutamic-pyruvic transaminase, Cr: creatinine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09545" y="291725"/>
            <a:ext cx="25949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. 1</a:t>
            </a:r>
            <a:r>
              <a:rPr lang="en-US" altLang="zh-CN" sz="1600" b="1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c</a:t>
            </a: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1417350" y="5150864"/>
            <a:ext cx="9357299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buFontTx/>
              <a:buNone/>
              <a:defRPr/>
            </a:pPr>
            <a:endParaRPr kumimoji="0" lang="zh-CN" altLang="zh-CN" sz="1200" b="1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687951" y="1529702"/>
            <a:ext cx="4065211" cy="2938158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305549" y="1156573"/>
            <a:ext cx="4065210" cy="3311287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1"/>
            </p:custDataLst>
          </p:nvPr>
        </p:nvSpPr>
        <p:spPr>
          <a:xfrm>
            <a:off x="1554910" y="5193353"/>
            <a:ext cx="1039177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buFontTx/>
              <a:buNone/>
              <a:defRPr/>
            </a:pPr>
            <a:r>
              <a:rPr lang="en-GB" altLang="zh-CN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 S1c Correlations of serum DKK1 level in OI children with  the number of peripheral fracture and  annual peripheral fracture</a:t>
            </a:r>
            <a:r>
              <a:rPr lang="en-US" altLang="en-GB" sz="1200" b="1" kern="1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incidence</a:t>
            </a:r>
            <a:endParaRPr kumimoji="0" lang="en-US" altLang="zh-CN" sz="1200" b="1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DEyYTAyNzdmODdiMzAxNzYwNjRhYThjMDA5ZGFlZjUifQ==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115</Words>
  <Application>Microsoft Office PowerPoint</Application>
  <PresentationFormat>宽屏</PresentationFormat>
  <Paragraphs>9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ye wang</dc:creator>
  <cp:lastModifiedBy>yanye wang</cp:lastModifiedBy>
  <cp:revision>23</cp:revision>
  <dcterms:created xsi:type="dcterms:W3CDTF">2024-01-06T10:11:00Z</dcterms:created>
  <dcterms:modified xsi:type="dcterms:W3CDTF">2024-01-22T11:43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ADECAF6A6C44417BF49233E1E28192D_12</vt:lpwstr>
  </property>
  <property fmtid="{D5CDD505-2E9C-101B-9397-08002B2CF9AE}" pid="3" name="KSOProductBuildVer">
    <vt:lpwstr>2052-12.1.0.16120</vt:lpwstr>
  </property>
</Properties>
</file>